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6" autoAdjust="0"/>
    <p:restoredTop sz="94660"/>
  </p:normalViewPr>
  <p:slideViewPr>
    <p:cSldViewPr snapToGrid="0" showGuides="1">
      <p:cViewPr varScale="1">
        <p:scale>
          <a:sx n="59" d="100"/>
          <a:sy n="59" d="100"/>
        </p:scale>
        <p:origin x="54" y="28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B0952FC-42D1-7B59-C48C-E0E754FA9A3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BDCF924-9724-A17F-B533-9D403417F52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4B75DE5-AE5D-8CA4-0771-9EF7B0CCE5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A93E6-3234-44BA-9F67-7A18CD53F594}" type="datetimeFigureOut">
              <a:rPr lang="zh-CN" altLang="en-US" smtClean="0"/>
              <a:t>2025/3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14A45A6-93AE-2605-0403-7CBA2DA75D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C856054-FD64-28D6-5746-A6A4279A44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A99703-BBE3-4EED-92E2-5C03D8751B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953025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207E1A0-D7B9-BDAB-B090-BC8E0D047F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5F210B0-3E82-8598-F72E-4D77D547F57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E9BD4ED-0BA7-2B65-D276-8F78336E6F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A93E6-3234-44BA-9F67-7A18CD53F594}" type="datetimeFigureOut">
              <a:rPr lang="zh-CN" altLang="en-US" smtClean="0"/>
              <a:t>2025/3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9203783-2976-D668-D5E7-1CA3272941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A8321F7-8460-B444-FC7B-ECC55D9659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A99703-BBE3-4EED-92E2-5C03D8751B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12455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524872C-B1F5-7F10-8F32-942E10CADB6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1E71773-AC33-14E7-5008-BDF40499F1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6A23879-E38D-08AF-F434-0B13AFD14A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A93E6-3234-44BA-9F67-7A18CD53F594}" type="datetimeFigureOut">
              <a:rPr lang="zh-CN" altLang="en-US" smtClean="0"/>
              <a:t>2025/3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50714A7-02BC-7FAC-6E31-1778F2A8D5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1F41793-9575-59FF-D335-747A0E8A43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A99703-BBE3-4EED-92E2-5C03D8751B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36006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BA6DFF2-1BA5-740D-048B-47A780C200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DD87C21-1B1A-7E99-D9DD-BA65039E31F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52AD015-1EE6-97E0-D678-6A807687A4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A93E6-3234-44BA-9F67-7A18CD53F594}" type="datetimeFigureOut">
              <a:rPr lang="zh-CN" altLang="en-US" smtClean="0"/>
              <a:t>2025/3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29CFBE7-3A16-5D6F-0D55-4BC0A1919B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3A37951-99EF-B4A3-D75A-1C966D43E4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A99703-BBE3-4EED-92E2-5C03D8751B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18079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A854DF0-C17E-2BA6-300D-D5439CCF8A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7F935C9-7287-749B-9860-ACEFA88CCF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099EE28-033E-F385-489E-724D21B045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A93E6-3234-44BA-9F67-7A18CD53F594}" type="datetimeFigureOut">
              <a:rPr lang="zh-CN" altLang="en-US" smtClean="0"/>
              <a:t>2025/3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61CB61C-DCB5-87AD-800A-B4814D5400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7FEB35F-D3A4-F92F-1ADD-658E9E7C0B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A99703-BBE3-4EED-92E2-5C03D8751B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83072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8552DD9-C2CD-A83E-0875-CC30B80BDD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3C0B38D-324F-0B80-26ED-9D11D4884B7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5CB8FA9-1C9B-1C4C-0D5A-DD93D8EC3BB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9A04724-B845-7B0C-1A0D-B0921B8CDA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A93E6-3234-44BA-9F67-7A18CD53F594}" type="datetimeFigureOut">
              <a:rPr lang="zh-CN" altLang="en-US" smtClean="0"/>
              <a:t>2025/3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0E3B418-C8B4-4DC7-4F7F-98F8567A5B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2C87B39-45FD-AA32-CDCA-2DD39207DC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A99703-BBE3-4EED-92E2-5C03D8751B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67378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271D01A-A3E6-511F-C056-62B049D2A7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E86ADF9-190F-0192-CFF0-48116A5A53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E4F0FBC-98D9-19BA-7F4B-06950CC9A9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22719C5-31B3-EBA2-9905-37C4291BFED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A24E47B-0320-0178-6BE4-87AFAE9FB07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73BEE00-AC1A-3841-5048-FEA9DC1E69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A93E6-3234-44BA-9F67-7A18CD53F594}" type="datetimeFigureOut">
              <a:rPr lang="zh-CN" altLang="en-US" smtClean="0"/>
              <a:t>2025/3/1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5A726C0-4E4A-BDB2-B2BC-5643DA4B74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28903DD3-FC4E-0568-244E-C1E8710713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A99703-BBE3-4EED-92E2-5C03D8751B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59049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E5D022A-7D6C-F111-5386-83EC1E5A05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C8EE5E9-58A1-0101-A31E-3629056C37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A93E6-3234-44BA-9F67-7A18CD53F594}" type="datetimeFigureOut">
              <a:rPr lang="zh-CN" altLang="en-US" smtClean="0"/>
              <a:t>2025/3/1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4296CB5-D7B4-0A1C-A058-4ED15077C6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ECACE96-88F7-5536-1A8E-B0F91207BC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A99703-BBE3-4EED-92E2-5C03D8751B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15315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CFBE8BE1-16CD-4513-7172-D2B2792DB5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A93E6-3234-44BA-9F67-7A18CD53F594}" type="datetimeFigureOut">
              <a:rPr lang="zh-CN" altLang="en-US" smtClean="0"/>
              <a:t>2025/3/1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CDFFE7A-BBEC-504E-5DF9-FC088662DF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334596D5-86A6-E503-CBAD-751525AB13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A99703-BBE3-4EED-92E2-5C03D8751B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062204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FB191E8-996D-3BA5-8A02-983EC1D49D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830CE7B-13F2-C10D-3D2A-768A6570F11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8F50EDB-B242-0D3C-5913-3EA0D34815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F2F2370-78EF-3A3E-C0B7-DFE6E84336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A93E6-3234-44BA-9F67-7A18CD53F594}" type="datetimeFigureOut">
              <a:rPr lang="zh-CN" altLang="en-US" smtClean="0"/>
              <a:t>2025/3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39BFE0F-3BB3-7F25-6128-72FA3A3F8B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630D667-D256-14BA-E729-B7F97CF145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A99703-BBE3-4EED-92E2-5C03D8751B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57003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A9CBCB0-478B-47A9-AB39-F4CC8DA87F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74617BAD-67E8-65F0-B347-3F7E9843AE8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00026C8-C527-9560-3F2F-9D0963F49C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2F20412-9282-3359-1464-6C8A9D3E7C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A93E6-3234-44BA-9F67-7A18CD53F594}" type="datetimeFigureOut">
              <a:rPr lang="zh-CN" altLang="en-US" smtClean="0"/>
              <a:t>2025/3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D16A758-CBED-C13E-5F1E-0C6B3F8A64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DB15787-FBC6-F243-661D-27393452F8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A99703-BBE3-4EED-92E2-5C03D8751B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4017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5F4D8C56-030D-4E00-6314-A7708FAE0B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0C84DE6-3B5D-AB3B-6671-739453E585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62A2E35-D695-0E81-F9A9-1EA8FD92089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1A93E6-3234-44BA-9F67-7A18CD53F594}" type="datetimeFigureOut">
              <a:rPr lang="zh-CN" altLang="en-US" smtClean="0"/>
              <a:t>2025/3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28FE639-739D-CD2B-B981-6E2FC239E9D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D024F73-ADC8-C05E-CA9C-C067ED9C182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A99703-BBE3-4EED-92E2-5C03D8751B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61499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画布 1">
            <a:extLst>
              <a:ext uri="{FF2B5EF4-FFF2-40B4-BE49-F238E27FC236}">
                <a16:creationId xmlns:a16="http://schemas.microsoft.com/office/drawing/2014/main" id="{B76FABB3-E561-76A8-830B-DD93826D3264}"/>
              </a:ext>
            </a:extLst>
          </p:cNvPr>
          <p:cNvGrpSpPr/>
          <p:nvPr/>
        </p:nvGrpSpPr>
        <p:grpSpPr>
          <a:xfrm>
            <a:off x="3774435" y="634694"/>
            <a:ext cx="6193768" cy="5262245"/>
            <a:chOff x="0" y="0"/>
            <a:chExt cx="6193768" cy="5262245"/>
          </a:xfrm>
        </p:grpSpPr>
        <p:sp>
          <p:nvSpPr>
            <p:cNvPr id="5" name="矩形 4">
              <a:extLst>
                <a:ext uri="{FF2B5EF4-FFF2-40B4-BE49-F238E27FC236}">
                  <a16:creationId xmlns:a16="http://schemas.microsoft.com/office/drawing/2014/main" id="{FA455E6A-E123-0973-EB2F-CE9EEA9E5E6A}"/>
                </a:ext>
              </a:extLst>
            </p:cNvPr>
            <p:cNvSpPr/>
            <p:nvPr/>
          </p:nvSpPr>
          <p:spPr>
            <a:xfrm>
              <a:off x="0" y="0"/>
              <a:ext cx="5274310" cy="4326255"/>
            </a:xfrm>
            <a:prstGeom prst="rect">
              <a:avLst/>
            </a:prstGeom>
            <a:solidFill>
              <a:prstClr val="white"/>
            </a:solidFill>
          </p:spPr>
        </p:sp>
        <p:sp>
          <p:nvSpPr>
            <p:cNvPr id="6" name="流程图: 过程 5">
              <a:extLst>
                <a:ext uri="{FF2B5EF4-FFF2-40B4-BE49-F238E27FC236}">
                  <a16:creationId xmlns:a16="http://schemas.microsoft.com/office/drawing/2014/main" id="{DC71158E-BFF2-8E27-824B-73EFC74926BD}"/>
                </a:ext>
              </a:extLst>
            </p:cNvPr>
            <p:cNvSpPr/>
            <p:nvPr/>
          </p:nvSpPr>
          <p:spPr>
            <a:xfrm>
              <a:off x="9525" y="166618"/>
              <a:ext cx="3800475" cy="600145"/>
            </a:xfrm>
            <a:prstGeom prst="flowChartProcess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76200" indent="-76200" algn="ctr">
                <a:buNone/>
              </a:pPr>
              <a:r>
                <a:rPr lang="en-US" sz="12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1302 maintenance hemodialysis patients enrolled in the cohort </a:t>
              </a:r>
              <a:r>
                <a:rPr lang="zh-CN" sz="12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（</a:t>
              </a:r>
              <a:r>
                <a:rPr lang="en-US" sz="12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January 2014-December 2015</a:t>
              </a:r>
              <a:r>
                <a:rPr lang="zh-CN" sz="12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）</a:t>
              </a:r>
              <a:endParaRPr lang="zh-CN" sz="1050" kern="100" dirty="0">
                <a:effectLst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ctr"/>
              <a:r>
                <a:rPr lang="en-US" sz="1050" kern="100" dirty="0">
                  <a:effectLst/>
                  <a:ea typeface="等线" panose="02010600030101010101" pitchFamily="2" charset="-122"/>
                  <a:cs typeface="Times New Roman" panose="02020603050405020304" pitchFamily="18" charset="0"/>
                </a:rPr>
                <a:t> </a:t>
              </a:r>
              <a:endParaRPr lang="zh-CN" sz="1050" kern="100" dirty="0">
                <a:effectLst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" name="流程图: 过程 6">
              <a:extLst>
                <a:ext uri="{FF2B5EF4-FFF2-40B4-BE49-F238E27FC236}">
                  <a16:creationId xmlns:a16="http://schemas.microsoft.com/office/drawing/2014/main" id="{E1084339-9571-A454-7F14-20D331E085B1}"/>
                </a:ext>
              </a:extLst>
            </p:cNvPr>
            <p:cNvSpPr/>
            <p:nvPr/>
          </p:nvSpPr>
          <p:spPr>
            <a:xfrm>
              <a:off x="23813" y="2460388"/>
              <a:ext cx="3786187" cy="406323"/>
            </a:xfrm>
            <a:prstGeom prst="flowChartProcess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1129 meet the inclusion criterion</a:t>
              </a:r>
              <a:endParaRPr lang="zh-CN" sz="1050" kern="100">
                <a:effectLst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8" name="流程图: 过程 7">
              <a:extLst>
                <a:ext uri="{FF2B5EF4-FFF2-40B4-BE49-F238E27FC236}">
                  <a16:creationId xmlns:a16="http://schemas.microsoft.com/office/drawing/2014/main" id="{D82985E6-66D5-59DD-821E-9406D4911B2A}"/>
                </a:ext>
              </a:extLst>
            </p:cNvPr>
            <p:cNvSpPr/>
            <p:nvPr/>
          </p:nvSpPr>
          <p:spPr>
            <a:xfrm>
              <a:off x="0" y="4862223"/>
              <a:ext cx="3843338" cy="400022"/>
            </a:xfrm>
            <a:prstGeom prst="flowChartProcess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1044 included in the final analysis</a:t>
              </a:r>
              <a:endParaRPr lang="zh-CN" sz="1050" kern="100">
                <a:effectLst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9" name="直接箭头连接符 8">
              <a:extLst>
                <a:ext uri="{FF2B5EF4-FFF2-40B4-BE49-F238E27FC236}">
                  <a16:creationId xmlns:a16="http://schemas.microsoft.com/office/drawing/2014/main" id="{D9EC5FAD-8493-0459-0667-92E364067939}"/>
                </a:ext>
              </a:extLst>
            </p:cNvPr>
            <p:cNvCxnSpPr>
              <a:stCxn id="6" idx="2"/>
              <a:endCxn id="7" idx="0"/>
            </p:cNvCxnSpPr>
            <p:nvPr/>
          </p:nvCxnSpPr>
          <p:spPr>
            <a:xfrm>
              <a:off x="1909763" y="766763"/>
              <a:ext cx="7144" cy="169362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" name="直接箭头连接符 9">
              <a:extLst>
                <a:ext uri="{FF2B5EF4-FFF2-40B4-BE49-F238E27FC236}">
                  <a16:creationId xmlns:a16="http://schemas.microsoft.com/office/drawing/2014/main" id="{2D2ADB9B-6E15-9808-B857-C63CD9902F9A}"/>
                </a:ext>
              </a:extLst>
            </p:cNvPr>
            <p:cNvCxnSpPr>
              <a:stCxn id="7" idx="2"/>
              <a:endCxn id="8" idx="0"/>
            </p:cNvCxnSpPr>
            <p:nvPr/>
          </p:nvCxnSpPr>
          <p:spPr>
            <a:xfrm>
              <a:off x="1916907" y="2866711"/>
              <a:ext cx="4762" cy="1995512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" name="流程图: 过程 10">
              <a:extLst>
                <a:ext uri="{FF2B5EF4-FFF2-40B4-BE49-F238E27FC236}">
                  <a16:creationId xmlns:a16="http://schemas.microsoft.com/office/drawing/2014/main" id="{80C697CF-30E4-A1D7-602D-5C4EA06C0E48}"/>
                </a:ext>
              </a:extLst>
            </p:cNvPr>
            <p:cNvSpPr/>
            <p:nvPr/>
          </p:nvSpPr>
          <p:spPr>
            <a:xfrm>
              <a:off x="3143251" y="1018048"/>
              <a:ext cx="3000374" cy="1091740"/>
            </a:xfrm>
            <a:prstGeom prst="flowChartProcess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76200" indent="-76200" algn="l">
                <a:buNone/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Excluded(N=173)</a:t>
              </a:r>
              <a:endParaRPr lang="zh-CN" sz="1050" kern="100">
                <a:effectLst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marL="342900" lvl="0" indent="-342900" algn="l">
                <a:buFont typeface="+mj-lt"/>
                <a:buAutoNum type="arabicParenR"/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Enrolled in the cohort twice (N=2)</a:t>
              </a:r>
              <a:endParaRPr lang="zh-CN" sz="1050" kern="100">
                <a:effectLst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marL="342900" lvl="0" indent="-342900" algn="l">
                <a:buFont typeface="+mj-lt"/>
                <a:buAutoNum type="arabicParenR"/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Peritoneal dialysis</a:t>
              </a:r>
              <a:r>
                <a:rPr lang="zh-CN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（</a:t>
              </a:r>
              <a:r>
                <a:rPr lang="en-US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N=8</a:t>
              </a:r>
              <a:r>
                <a:rPr lang="zh-CN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）</a:t>
              </a:r>
              <a:endParaRPr lang="zh-CN" sz="1050" kern="100">
                <a:effectLst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marL="342900" lvl="0" indent="-342900" algn="l">
                <a:buFont typeface="+mj-lt"/>
                <a:buAutoNum type="arabicParenR"/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Dialysis duration &lt;3 months (N=163)</a:t>
              </a:r>
              <a:endParaRPr lang="zh-CN" sz="1050" kern="100">
                <a:effectLst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marL="76200" indent="-76200" algn="l"/>
              <a:r>
                <a:rPr lang="en-US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 </a:t>
              </a:r>
              <a:endParaRPr lang="zh-CN" sz="1050" kern="100">
                <a:effectLst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12" name="直接箭头连接符 11">
              <a:extLst>
                <a:ext uri="{FF2B5EF4-FFF2-40B4-BE49-F238E27FC236}">
                  <a16:creationId xmlns:a16="http://schemas.microsoft.com/office/drawing/2014/main" id="{0248A6B1-4659-32C9-F9B0-627E4288F5C4}"/>
                </a:ext>
              </a:extLst>
            </p:cNvPr>
            <p:cNvCxnSpPr>
              <a:endCxn id="11" idx="1"/>
            </p:cNvCxnSpPr>
            <p:nvPr/>
          </p:nvCxnSpPr>
          <p:spPr>
            <a:xfrm>
              <a:off x="1924050" y="1556509"/>
              <a:ext cx="1219201" cy="740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流程图: 过程 12">
              <a:extLst>
                <a:ext uri="{FF2B5EF4-FFF2-40B4-BE49-F238E27FC236}">
                  <a16:creationId xmlns:a16="http://schemas.microsoft.com/office/drawing/2014/main" id="{20D4072B-8909-847C-7054-66E6A0543CAA}"/>
                </a:ext>
              </a:extLst>
            </p:cNvPr>
            <p:cNvSpPr/>
            <p:nvPr/>
          </p:nvSpPr>
          <p:spPr>
            <a:xfrm>
              <a:off x="3194028" y="3122830"/>
              <a:ext cx="2999740" cy="1568232"/>
            </a:xfrm>
            <a:prstGeom prst="flowChartProcess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76200" indent="-76200" algn="l">
                <a:buNone/>
              </a:pPr>
              <a:r>
                <a:rPr lang="en-US" sz="12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Excluded(N=95)</a:t>
              </a:r>
              <a:endParaRPr lang="zh-CN" sz="1050" kern="100" dirty="0">
                <a:effectLst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marL="342900" lvl="0" indent="-342900" algn="l">
                <a:buFont typeface="+mj-lt"/>
                <a:buAutoNum type="arabicParenR"/>
              </a:pPr>
              <a:r>
                <a:rPr lang="en-US" sz="12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Kt/V missing (n=68)</a:t>
              </a:r>
              <a:endParaRPr lang="zh-CN" sz="1050" kern="100" dirty="0">
                <a:effectLst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marL="342900" lvl="0" indent="-342900" algn="l">
                <a:buFont typeface="+mj-lt"/>
                <a:buAutoNum type="arabicParenR"/>
              </a:pPr>
              <a:r>
                <a:rPr lang="en-US" sz="12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CRP missing</a:t>
              </a:r>
              <a:r>
                <a:rPr lang="zh-CN" sz="12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（</a:t>
              </a:r>
              <a:r>
                <a:rPr lang="en-US" sz="12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n=13</a:t>
              </a:r>
              <a:r>
                <a:rPr lang="zh-CN" sz="12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）</a:t>
              </a:r>
              <a:endParaRPr lang="zh-CN" sz="1050" kern="100" dirty="0">
                <a:effectLst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marL="342900" lvl="0" indent="-342900" algn="l">
                <a:lnSpc>
                  <a:spcPct val="150000"/>
                </a:lnSpc>
                <a:buFont typeface="+mj-lt"/>
                <a:buAutoNum type="arabicParenR"/>
              </a:pPr>
              <a:r>
                <a:rPr lang="en-US" sz="12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CHOL missing(n=4)</a:t>
              </a:r>
              <a:endParaRPr lang="zh-CN" sz="1050" kern="100" dirty="0">
                <a:effectLst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14" name="直接箭头连接符 13">
              <a:extLst>
                <a:ext uri="{FF2B5EF4-FFF2-40B4-BE49-F238E27FC236}">
                  <a16:creationId xmlns:a16="http://schemas.microsoft.com/office/drawing/2014/main" id="{AF17A8C1-5904-A0CB-9813-3A254FE8FFDE}"/>
                </a:ext>
              </a:extLst>
            </p:cNvPr>
            <p:cNvCxnSpPr>
              <a:endCxn id="13" idx="1"/>
            </p:cNvCxnSpPr>
            <p:nvPr/>
          </p:nvCxnSpPr>
          <p:spPr>
            <a:xfrm>
              <a:off x="1928813" y="3906714"/>
              <a:ext cx="1265215" cy="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7" name="文本框 16">
            <a:extLst>
              <a:ext uri="{FF2B5EF4-FFF2-40B4-BE49-F238E27FC236}">
                <a16:creationId xmlns:a16="http://schemas.microsoft.com/office/drawing/2014/main" id="{173FDC5B-A9AB-3515-D552-9BD12E8897DF}"/>
              </a:ext>
            </a:extLst>
          </p:cNvPr>
          <p:cNvSpPr txBox="1"/>
          <p:nvPr/>
        </p:nvSpPr>
        <p:spPr>
          <a:xfrm>
            <a:off x="3559147" y="6186697"/>
            <a:ext cx="57048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69850" algn="ctr"/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</a:t>
            </a:r>
            <a:r>
              <a:rPr lang="en-US" altLang="zh-CN" sz="18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1: Participant flow chart.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706549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96</Words>
  <Application>Microsoft Office PowerPoint</Application>
  <PresentationFormat>宽屏</PresentationFormat>
  <Paragraphs>1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秋霞 钟</dc:creator>
  <cp:lastModifiedBy>秋霞 钟</cp:lastModifiedBy>
  <cp:revision>1</cp:revision>
  <dcterms:created xsi:type="dcterms:W3CDTF">2025-03-13T15:56:03Z</dcterms:created>
  <dcterms:modified xsi:type="dcterms:W3CDTF">2025-03-13T15:57:32Z</dcterms:modified>
</cp:coreProperties>
</file>